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999538" cy="12960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4" d="100"/>
          <a:sy n="44" d="100"/>
        </p:scale>
        <p:origin x="262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121058"/>
            <a:ext cx="7649607" cy="451212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6807185"/>
            <a:ext cx="6749654" cy="3129084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0346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2643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690018"/>
            <a:ext cx="1940525" cy="1098329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90018"/>
            <a:ext cx="5709082" cy="1098329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0350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2038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231091"/>
            <a:ext cx="7762102" cy="5391145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8673238"/>
            <a:ext cx="7762102" cy="283507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6147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450093"/>
            <a:ext cx="3824804" cy="822322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450093"/>
            <a:ext cx="3824804" cy="822322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4911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90021"/>
            <a:ext cx="7762102" cy="2505069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177087"/>
            <a:ext cx="3807226" cy="155704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4734128"/>
            <a:ext cx="3807226" cy="696318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177087"/>
            <a:ext cx="3825976" cy="155704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734128"/>
            <a:ext cx="3825976" cy="696318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6931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391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5496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64023"/>
            <a:ext cx="2902585" cy="302408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866053"/>
            <a:ext cx="4556016" cy="9210249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888105"/>
            <a:ext cx="2902585" cy="720319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7470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64023"/>
            <a:ext cx="2902585" cy="302408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866053"/>
            <a:ext cx="4556016" cy="9210249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888105"/>
            <a:ext cx="2902585" cy="720319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3996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690021"/>
            <a:ext cx="7762102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450093"/>
            <a:ext cx="7762102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2012327"/>
            <a:ext cx="2024896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F19CE-BAE6-4569-8B72-3CF8E012862E}" type="datetimeFigureOut">
              <a:rPr lang="de-DE" smtClean="0"/>
              <a:t>2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2012327"/>
            <a:ext cx="3037344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2012327"/>
            <a:ext cx="2024896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11193-FF8D-4754-B78F-3C4EF7EB9E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8783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377DE813-28FE-4296-B5E1-B97A599827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40" y="764072"/>
            <a:ext cx="5096263" cy="12013211"/>
          </a:xfrm>
          <a:prstGeom prst="rect">
            <a:avLst/>
          </a:prstGeom>
        </p:spPr>
      </p:pic>
      <p:sp>
        <p:nvSpPr>
          <p:cNvPr id="11" name="Pfeil: nach rechts 10">
            <a:extLst>
              <a:ext uri="{FF2B5EF4-FFF2-40B4-BE49-F238E27FC236}">
                <a16:creationId xmlns:a16="http://schemas.microsoft.com/office/drawing/2014/main" id="{ED04F9ED-EDB7-4961-A8A1-014E32E95ED3}"/>
              </a:ext>
            </a:extLst>
          </p:cNvPr>
          <p:cNvSpPr/>
          <p:nvPr/>
        </p:nvSpPr>
        <p:spPr>
          <a:xfrm rot="10800000">
            <a:off x="3537346" y="3053282"/>
            <a:ext cx="281940" cy="12192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A10EFC3-8580-4048-9182-F8CCDC4C9E13}"/>
              </a:ext>
            </a:extLst>
          </p:cNvPr>
          <p:cNvSpPr txBox="1"/>
          <p:nvPr/>
        </p:nvSpPr>
        <p:spPr>
          <a:xfrm>
            <a:off x="4319740" y="5037031"/>
            <a:ext cx="1694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/>
              <a:t>R. </a:t>
            </a:r>
            <a:r>
              <a:rPr lang="de-DE" i="1"/>
              <a:t>pseudoacacia</a:t>
            </a:r>
            <a:endParaRPr lang="de-DE" i="1" dirty="0"/>
          </a:p>
        </p:txBody>
      </p:sp>
      <p:sp>
        <p:nvSpPr>
          <p:cNvPr id="19" name="Pfeil: nach rechts 18">
            <a:extLst>
              <a:ext uri="{FF2B5EF4-FFF2-40B4-BE49-F238E27FC236}">
                <a16:creationId xmlns:a16="http://schemas.microsoft.com/office/drawing/2014/main" id="{4E3C36B0-0430-4BD3-AD1E-99E8BE2BF6DF}"/>
              </a:ext>
            </a:extLst>
          </p:cNvPr>
          <p:cNvSpPr/>
          <p:nvPr/>
        </p:nvSpPr>
        <p:spPr>
          <a:xfrm rot="10800000">
            <a:off x="3413522" y="5948880"/>
            <a:ext cx="281940" cy="12192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252A3F86-F68A-403C-9587-1FE053DF4726}"/>
              </a:ext>
            </a:extLst>
          </p:cNvPr>
          <p:cNvSpPr/>
          <p:nvPr/>
        </p:nvSpPr>
        <p:spPr>
          <a:xfrm>
            <a:off x="4003889" y="2107722"/>
            <a:ext cx="155358" cy="5858621"/>
          </a:xfrm>
          <a:prstGeom prst="rect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571ACCFA-86CB-4037-AA57-53FB1DB873B4}"/>
              </a:ext>
            </a:extLst>
          </p:cNvPr>
          <p:cNvSpPr/>
          <p:nvPr/>
        </p:nvSpPr>
        <p:spPr>
          <a:xfrm>
            <a:off x="4003889" y="764072"/>
            <a:ext cx="155358" cy="1290189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highlight>
                <a:srgbClr val="FF0000"/>
              </a:highlight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98DACD6F-822C-4330-9587-B8C76A7915C1}"/>
              </a:ext>
            </a:extLst>
          </p:cNvPr>
          <p:cNvSpPr txBox="1"/>
          <p:nvPr/>
        </p:nvSpPr>
        <p:spPr>
          <a:xfrm>
            <a:off x="4228633" y="1147839"/>
            <a:ext cx="2194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other</a:t>
            </a:r>
            <a:r>
              <a:rPr lang="de-DE" dirty="0"/>
              <a:t> </a:t>
            </a:r>
            <a:r>
              <a:rPr lang="de-DE" i="1" dirty="0"/>
              <a:t>Robinia </a:t>
            </a:r>
            <a:r>
              <a:rPr lang="de-DE" dirty="0" err="1"/>
              <a:t>species</a:t>
            </a:r>
            <a:endParaRPr lang="de-DE" dirty="0"/>
          </a:p>
        </p:txBody>
      </p:sp>
      <p:sp>
        <p:nvSpPr>
          <p:cNvPr id="23" name="Rechteck 22">
            <a:extLst>
              <a:ext uri="{FF2B5EF4-FFF2-40B4-BE49-F238E27FC236}">
                <a16:creationId xmlns:a16="http://schemas.microsoft.com/office/drawing/2014/main" id="{B89DAF8A-F7CA-4D07-B10A-BC1ABDCFD85F}"/>
              </a:ext>
            </a:extLst>
          </p:cNvPr>
          <p:cNvSpPr/>
          <p:nvPr/>
        </p:nvSpPr>
        <p:spPr>
          <a:xfrm>
            <a:off x="4003889" y="8019803"/>
            <a:ext cx="155358" cy="1940209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highlight>
                <a:srgbClr val="FF0000"/>
              </a:highlight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530BEE3-FB78-4A48-B5C1-E329D5C37BCC}"/>
              </a:ext>
            </a:extLst>
          </p:cNvPr>
          <p:cNvSpPr txBox="1"/>
          <p:nvPr/>
        </p:nvSpPr>
        <p:spPr>
          <a:xfrm>
            <a:off x="4228633" y="8403569"/>
            <a:ext cx="2194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other</a:t>
            </a:r>
            <a:r>
              <a:rPr lang="de-DE" dirty="0"/>
              <a:t> </a:t>
            </a:r>
            <a:r>
              <a:rPr lang="de-DE" i="1" dirty="0"/>
              <a:t>Robinia </a:t>
            </a:r>
            <a:r>
              <a:rPr lang="de-DE" dirty="0" err="1"/>
              <a:t>species</a:t>
            </a:r>
            <a:endParaRPr lang="de-DE" dirty="0"/>
          </a:p>
        </p:txBody>
      </p:sp>
      <p:sp>
        <p:nvSpPr>
          <p:cNvPr id="25" name="Pfeil: nach rechts 24">
            <a:extLst>
              <a:ext uri="{FF2B5EF4-FFF2-40B4-BE49-F238E27FC236}">
                <a16:creationId xmlns:a16="http://schemas.microsoft.com/office/drawing/2014/main" id="{34D4D76B-6752-4E90-B978-44DD0565EE42}"/>
              </a:ext>
            </a:extLst>
          </p:cNvPr>
          <p:cNvSpPr/>
          <p:nvPr/>
        </p:nvSpPr>
        <p:spPr>
          <a:xfrm rot="10800000">
            <a:off x="3652552" y="5682875"/>
            <a:ext cx="281940" cy="121920"/>
          </a:xfrm>
          <a:prstGeom prst="rightArrow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Pfeil: nach rechts 25">
            <a:extLst>
              <a:ext uri="{FF2B5EF4-FFF2-40B4-BE49-F238E27FC236}">
                <a16:creationId xmlns:a16="http://schemas.microsoft.com/office/drawing/2014/main" id="{B6DE67A4-78C7-41D3-8D4C-9ED8DA03C512}"/>
              </a:ext>
            </a:extLst>
          </p:cNvPr>
          <p:cNvSpPr/>
          <p:nvPr/>
        </p:nvSpPr>
        <p:spPr>
          <a:xfrm rot="10800000">
            <a:off x="3660552" y="4521863"/>
            <a:ext cx="281940" cy="121920"/>
          </a:xfrm>
          <a:prstGeom prst="rightArrow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id="{EA4F336C-7911-4F02-8073-89239CFD6A2D}"/>
              </a:ext>
            </a:extLst>
          </p:cNvPr>
          <p:cNvSpPr/>
          <p:nvPr/>
        </p:nvSpPr>
        <p:spPr>
          <a:xfrm>
            <a:off x="5611709" y="10047641"/>
            <a:ext cx="155358" cy="165354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highlight>
                <a:srgbClr val="FF0000"/>
              </a:highlight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B5D56844-2F6B-49F9-A7AD-D87048DAE348}"/>
              </a:ext>
            </a:extLst>
          </p:cNvPr>
          <p:cNvSpPr txBox="1"/>
          <p:nvPr/>
        </p:nvSpPr>
        <p:spPr>
          <a:xfrm>
            <a:off x="5767067" y="10654921"/>
            <a:ext cx="1903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eighbouring</a:t>
            </a:r>
            <a:r>
              <a:rPr lang="de-DE" dirty="0"/>
              <a:t> </a:t>
            </a:r>
            <a:r>
              <a:rPr lang="de-DE" dirty="0" err="1"/>
              <a:t>taxa</a:t>
            </a:r>
            <a:endParaRPr lang="de-DE" dirty="0"/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44215AF3-E380-4E99-AFA6-88EEF831DA2F}"/>
              </a:ext>
            </a:extLst>
          </p:cNvPr>
          <p:cNvSpPr/>
          <p:nvPr/>
        </p:nvSpPr>
        <p:spPr>
          <a:xfrm>
            <a:off x="5611709" y="11754867"/>
            <a:ext cx="155358" cy="222048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highlight>
                <a:srgbClr val="FF0000"/>
              </a:highlight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A197786E-470C-4411-916D-BE6CB08C0B02}"/>
              </a:ext>
            </a:extLst>
          </p:cNvPr>
          <p:cNvSpPr txBox="1"/>
          <p:nvPr/>
        </p:nvSpPr>
        <p:spPr>
          <a:xfrm>
            <a:off x="5767068" y="11681225"/>
            <a:ext cx="2983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err="1"/>
              <a:t>Laburnum</a:t>
            </a:r>
            <a:r>
              <a:rPr lang="de-DE" dirty="0"/>
              <a:t> (</a:t>
            </a:r>
            <a:r>
              <a:rPr lang="de-DE" dirty="0" err="1"/>
              <a:t>confusion</a:t>
            </a:r>
            <a:r>
              <a:rPr lang="de-DE" dirty="0"/>
              <a:t> </a:t>
            </a:r>
            <a:r>
              <a:rPr lang="de-DE" dirty="0" err="1"/>
              <a:t>species</a:t>
            </a:r>
            <a:r>
              <a:rPr lang="de-DE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201627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Office PowerPoint</Application>
  <PresentationFormat>Benutzerdefiniert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ck, Peter (BOTANIK)</dc:creator>
  <cp:lastModifiedBy>Nick, Peter (JKIP)</cp:lastModifiedBy>
  <cp:revision>6</cp:revision>
  <dcterms:created xsi:type="dcterms:W3CDTF">2021-09-25T07:23:04Z</dcterms:created>
  <dcterms:modified xsi:type="dcterms:W3CDTF">2023-07-20T17:19:57Z</dcterms:modified>
</cp:coreProperties>
</file>